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7920038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73" autoAdjust="0"/>
    <p:restoredTop sz="94660"/>
  </p:normalViewPr>
  <p:slideViewPr>
    <p:cSldViewPr snapToGrid="0">
      <p:cViewPr varScale="1">
        <p:scale>
          <a:sx n="47" d="100"/>
          <a:sy n="47" d="100"/>
        </p:scale>
        <p:origin x="931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4003" y="1995312"/>
            <a:ext cx="6732032" cy="4244622"/>
          </a:xfrm>
        </p:spPr>
        <p:txBody>
          <a:bodyPr anchor="b"/>
          <a:lstStyle>
            <a:lvl1pPr algn="ctr">
              <a:defRPr sz="519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6403623"/>
            <a:ext cx="5940029" cy="2943577"/>
          </a:xfrm>
        </p:spPr>
        <p:txBody>
          <a:bodyPr/>
          <a:lstStyle>
            <a:lvl1pPr marL="0" indent="0" algn="ctr">
              <a:buNone/>
              <a:defRPr sz="2079"/>
            </a:lvl1pPr>
            <a:lvl2pPr marL="395981" indent="0" algn="ctr">
              <a:buNone/>
              <a:defRPr sz="1732"/>
            </a:lvl2pPr>
            <a:lvl3pPr marL="791962" indent="0" algn="ctr">
              <a:buNone/>
              <a:defRPr sz="1559"/>
            </a:lvl3pPr>
            <a:lvl4pPr marL="1187943" indent="0" algn="ctr">
              <a:buNone/>
              <a:defRPr sz="1386"/>
            </a:lvl4pPr>
            <a:lvl5pPr marL="1583924" indent="0" algn="ctr">
              <a:buNone/>
              <a:defRPr sz="1386"/>
            </a:lvl5pPr>
            <a:lvl6pPr marL="1979905" indent="0" algn="ctr">
              <a:buNone/>
              <a:defRPr sz="1386"/>
            </a:lvl6pPr>
            <a:lvl7pPr marL="2375886" indent="0" algn="ctr">
              <a:buNone/>
              <a:defRPr sz="1386"/>
            </a:lvl7pPr>
            <a:lvl8pPr marL="2771866" indent="0" algn="ctr">
              <a:buNone/>
              <a:defRPr sz="1386"/>
            </a:lvl8pPr>
            <a:lvl9pPr marL="3167847" indent="0" algn="ctr">
              <a:buNone/>
              <a:defRPr sz="1386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AFFD-4A42-4597-BB69-9C3FDF62FD67}" type="datetimeFigureOut">
              <a:rPr lang="en-AU" smtClean="0"/>
              <a:t>30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AEE2-AE8E-47C7-9869-3E1BE1041B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74937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AFFD-4A42-4597-BB69-9C3FDF62FD67}" type="datetimeFigureOut">
              <a:rPr lang="en-AU" smtClean="0"/>
              <a:t>30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AEE2-AE8E-47C7-9869-3E1BE1041B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09437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8" y="649111"/>
            <a:ext cx="1707758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649111"/>
            <a:ext cx="502427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AFFD-4A42-4597-BB69-9C3FDF62FD67}" type="datetimeFigureOut">
              <a:rPr lang="en-AU" smtClean="0"/>
              <a:t>30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AEE2-AE8E-47C7-9869-3E1BE1041B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63509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AFFD-4A42-4597-BB69-9C3FDF62FD67}" type="datetimeFigureOut">
              <a:rPr lang="en-AU" smtClean="0"/>
              <a:t>30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AEE2-AE8E-47C7-9869-3E1BE1041B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59984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8" y="3039537"/>
            <a:ext cx="6831033" cy="5071532"/>
          </a:xfrm>
        </p:spPr>
        <p:txBody>
          <a:bodyPr anchor="b"/>
          <a:lstStyle>
            <a:lvl1pPr>
              <a:defRPr sz="519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8" y="8159048"/>
            <a:ext cx="6831033" cy="2666999"/>
          </a:xfrm>
        </p:spPr>
        <p:txBody>
          <a:bodyPr/>
          <a:lstStyle>
            <a:lvl1pPr marL="0" indent="0">
              <a:buNone/>
              <a:defRPr sz="2079">
                <a:solidFill>
                  <a:schemeClr val="tx1"/>
                </a:solidFill>
              </a:defRPr>
            </a:lvl1pPr>
            <a:lvl2pPr marL="395981" indent="0">
              <a:buNone/>
              <a:defRPr sz="1732">
                <a:solidFill>
                  <a:schemeClr val="tx1">
                    <a:tint val="75000"/>
                  </a:schemeClr>
                </a:solidFill>
              </a:defRPr>
            </a:lvl2pPr>
            <a:lvl3pPr marL="791962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3pPr>
            <a:lvl4pPr marL="1187943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4pPr>
            <a:lvl5pPr marL="1583924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5pPr>
            <a:lvl6pPr marL="1979905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6pPr>
            <a:lvl7pPr marL="237588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7pPr>
            <a:lvl8pPr marL="277186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8pPr>
            <a:lvl9pPr marL="3167847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AFFD-4A42-4597-BB69-9C3FDF62FD67}" type="datetimeFigureOut">
              <a:rPr lang="en-AU" smtClean="0"/>
              <a:t>30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AEE2-AE8E-47C7-9869-3E1BE1041B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111381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3245556"/>
            <a:ext cx="3366016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3245556"/>
            <a:ext cx="3366016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AFFD-4A42-4597-BB69-9C3FDF62FD67}" type="datetimeFigureOut">
              <a:rPr lang="en-AU" smtClean="0"/>
              <a:t>30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AEE2-AE8E-47C7-9869-3E1BE1041B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06568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649114"/>
            <a:ext cx="6831033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2988734"/>
            <a:ext cx="3350547" cy="1464732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4453467"/>
            <a:ext cx="3350547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20" y="2988734"/>
            <a:ext cx="3367048" cy="1464732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20" y="4453467"/>
            <a:ext cx="3367048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AFFD-4A42-4597-BB69-9C3FDF62FD67}" type="datetimeFigureOut">
              <a:rPr lang="en-AU" smtClean="0"/>
              <a:t>30/07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AEE2-AE8E-47C7-9869-3E1BE1041B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0785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AFFD-4A42-4597-BB69-9C3FDF62FD67}" type="datetimeFigureOut">
              <a:rPr lang="en-AU" smtClean="0"/>
              <a:t>30/07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AEE2-AE8E-47C7-9869-3E1BE1041B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51083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AFFD-4A42-4597-BB69-9C3FDF62FD67}" type="datetimeFigureOut">
              <a:rPr lang="en-AU" smtClean="0"/>
              <a:t>30/07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AEE2-AE8E-47C7-9869-3E1BE1041B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243086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812800"/>
            <a:ext cx="2554418" cy="2844800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1755425"/>
            <a:ext cx="4009519" cy="8664222"/>
          </a:xfrm>
        </p:spPr>
        <p:txBody>
          <a:bodyPr/>
          <a:lstStyle>
            <a:lvl1pPr>
              <a:defRPr sz="2772"/>
            </a:lvl1pPr>
            <a:lvl2pPr>
              <a:defRPr sz="2425"/>
            </a:lvl2pPr>
            <a:lvl3pPr>
              <a:defRPr sz="2079"/>
            </a:lvl3pPr>
            <a:lvl4pPr>
              <a:defRPr sz="1732"/>
            </a:lvl4pPr>
            <a:lvl5pPr>
              <a:defRPr sz="1732"/>
            </a:lvl5pPr>
            <a:lvl6pPr>
              <a:defRPr sz="1732"/>
            </a:lvl6pPr>
            <a:lvl7pPr>
              <a:defRPr sz="1732"/>
            </a:lvl7pPr>
            <a:lvl8pPr>
              <a:defRPr sz="1732"/>
            </a:lvl8pPr>
            <a:lvl9pPr>
              <a:defRPr sz="1732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3657600"/>
            <a:ext cx="2554418" cy="6776156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AFFD-4A42-4597-BB69-9C3FDF62FD67}" type="datetimeFigureOut">
              <a:rPr lang="en-AU" smtClean="0"/>
              <a:t>30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AEE2-AE8E-47C7-9869-3E1BE1041B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0793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812800"/>
            <a:ext cx="2554418" cy="2844800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1755425"/>
            <a:ext cx="4009519" cy="8664222"/>
          </a:xfrm>
        </p:spPr>
        <p:txBody>
          <a:bodyPr anchor="t"/>
          <a:lstStyle>
            <a:lvl1pPr marL="0" indent="0">
              <a:buNone/>
              <a:defRPr sz="2772"/>
            </a:lvl1pPr>
            <a:lvl2pPr marL="395981" indent="0">
              <a:buNone/>
              <a:defRPr sz="2425"/>
            </a:lvl2pPr>
            <a:lvl3pPr marL="791962" indent="0">
              <a:buNone/>
              <a:defRPr sz="2079"/>
            </a:lvl3pPr>
            <a:lvl4pPr marL="1187943" indent="0">
              <a:buNone/>
              <a:defRPr sz="1732"/>
            </a:lvl4pPr>
            <a:lvl5pPr marL="1583924" indent="0">
              <a:buNone/>
              <a:defRPr sz="1732"/>
            </a:lvl5pPr>
            <a:lvl6pPr marL="1979905" indent="0">
              <a:buNone/>
              <a:defRPr sz="1732"/>
            </a:lvl6pPr>
            <a:lvl7pPr marL="2375886" indent="0">
              <a:buNone/>
              <a:defRPr sz="1732"/>
            </a:lvl7pPr>
            <a:lvl8pPr marL="2771866" indent="0">
              <a:buNone/>
              <a:defRPr sz="1732"/>
            </a:lvl8pPr>
            <a:lvl9pPr marL="3167847" indent="0">
              <a:buNone/>
              <a:defRPr sz="1732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3657600"/>
            <a:ext cx="2554418" cy="6776156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AFFD-4A42-4597-BB69-9C3FDF62FD67}" type="datetimeFigureOut">
              <a:rPr lang="en-AU" smtClean="0"/>
              <a:t>30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AEE2-AE8E-47C7-9869-3E1BE1041B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5280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649114"/>
            <a:ext cx="6831033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3245556"/>
            <a:ext cx="6831033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11300181"/>
            <a:ext cx="1782009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6DAFFD-4A42-4597-BB69-9C3FDF62FD67}" type="datetimeFigureOut">
              <a:rPr lang="en-AU" smtClean="0"/>
              <a:t>30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11300181"/>
            <a:ext cx="2673013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11300181"/>
            <a:ext cx="1782009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AAAEE2-AE8E-47C7-9869-3E1BE1041B0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3121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91962" rtl="0" eaLnBrk="1" latinLnBrk="0" hangingPunct="1">
        <a:lnSpc>
          <a:spcPct val="90000"/>
        </a:lnSpc>
        <a:spcBef>
          <a:spcPct val="0"/>
        </a:spcBef>
        <a:buNone/>
        <a:defRPr sz="38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7990" indent="-197990" algn="l" defTabSz="791962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2425" kern="1200">
          <a:solidFill>
            <a:schemeClr val="tx1"/>
          </a:solidFill>
          <a:latin typeface="+mn-lt"/>
          <a:ea typeface="+mn-ea"/>
          <a:cs typeface="+mn-cs"/>
        </a:defRPr>
      </a:lvl1pPr>
      <a:lvl2pPr marL="593971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989952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732" kern="1200">
          <a:solidFill>
            <a:schemeClr val="tx1"/>
          </a:solidFill>
          <a:latin typeface="+mn-lt"/>
          <a:ea typeface="+mn-ea"/>
          <a:cs typeface="+mn-cs"/>
        </a:defRPr>
      </a:lvl3pPr>
      <a:lvl4pPr marL="1385933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781914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2177895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573876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969857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365838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1pPr>
      <a:lvl2pPr marL="395981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91962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3pPr>
      <a:lvl4pPr marL="1187943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583924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1979905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37588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77186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167847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346841" y="480877"/>
            <a:ext cx="7220607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orting information</a:t>
            </a:r>
            <a:endParaRPr kumimoji="0" lang="en-AU" altLang="en-US" sz="5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AU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5121" name="Picture 4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8634" y="3089986"/>
            <a:ext cx="5730875" cy="2968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263087" y="1898643"/>
            <a:ext cx="7388113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 Fig. Representative Alizarin Red stains of differentiating KOA and NOF osteoblast/osteocyte-like cultures. </a:t>
            </a:r>
            <a:endParaRPr kumimoji="0" lang="en-AU" altLang="en-US" sz="5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AU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17216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4</TotalTime>
  <Words>17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he University of Adelaid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herine Stapledon</dc:creator>
  <cp:lastModifiedBy>Gerald Atkins</cp:lastModifiedBy>
  <cp:revision>30</cp:revision>
  <dcterms:created xsi:type="dcterms:W3CDTF">2019-01-17T03:15:44Z</dcterms:created>
  <dcterms:modified xsi:type="dcterms:W3CDTF">2019-07-30T08:27:50Z</dcterms:modified>
</cp:coreProperties>
</file>